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75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45" d="100"/>
          <a:sy n="45" d="100"/>
        </p:scale>
        <p:origin x="1544" y="44"/>
      </p:cViewPr>
      <p:guideLst>
        <p:guide orient="horz" pos="3075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206298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911917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109515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25195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888538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343138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066003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66569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562807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67573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94457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743121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85167E60-8A96-3967-43D7-D19ACACF1C21}"/>
              </a:ext>
            </a:extLst>
          </p:cNvPr>
          <p:cNvGrpSpPr/>
          <p:nvPr/>
        </p:nvGrpSpPr>
        <p:grpSpPr>
          <a:xfrm>
            <a:off x="353002" y="1571901"/>
            <a:ext cx="6178749" cy="3136380"/>
            <a:chOff x="0" y="0"/>
            <a:chExt cx="5731564" cy="2508475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773821A2-B421-D891-7988-E74D10A276A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31586" t="27592" r="45567" b="10740"/>
            <a:stretch/>
          </p:blipFill>
          <p:spPr>
            <a:xfrm>
              <a:off x="1013789" y="25374"/>
              <a:ext cx="1457741" cy="248310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58DF430B-AD07-5BA9-7334-EAAE368B969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18116" t="14924" r="21015" b="12891"/>
            <a:stretch/>
          </p:blipFill>
          <p:spPr>
            <a:xfrm>
              <a:off x="3107633" y="325229"/>
              <a:ext cx="2623931" cy="2183246"/>
            </a:xfrm>
            <a:prstGeom prst="rect">
              <a:avLst/>
            </a:prstGeom>
          </p:spPr>
        </p:pic>
        <p:sp>
          <p:nvSpPr>
            <p:cNvPr id="7" name="TextBox 16">
              <a:extLst>
                <a:ext uri="{FF2B5EF4-FFF2-40B4-BE49-F238E27FC236}">
                  <a16:creationId xmlns:a16="http://schemas.microsoft.com/office/drawing/2014/main" id="{54B580B4-D73E-CBD4-9F6C-A17FA0703210}"/>
                </a:ext>
              </a:extLst>
            </p:cNvPr>
            <p:cNvSpPr txBox="1"/>
            <p:nvPr/>
          </p:nvSpPr>
          <p:spPr>
            <a:xfrm>
              <a:off x="0" y="0"/>
              <a:ext cx="332740" cy="22415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lnSpc>
                  <a:spcPct val="106000"/>
                </a:lnSpc>
                <a:spcAft>
                  <a:spcPts val="800"/>
                </a:spcAft>
              </a:pPr>
              <a:r>
                <a:rPr lang="en-US" sz="1000" b="1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.</a:t>
              </a:r>
              <a:endParaRPr lang="en-IN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16">
              <a:extLst>
                <a:ext uri="{FF2B5EF4-FFF2-40B4-BE49-F238E27FC236}">
                  <a16:creationId xmlns:a16="http://schemas.microsoft.com/office/drawing/2014/main" id="{0368AEB0-B1C1-3870-F2D8-AAF1AB5F406C}"/>
                </a:ext>
              </a:extLst>
            </p:cNvPr>
            <p:cNvSpPr txBox="1"/>
            <p:nvPr/>
          </p:nvSpPr>
          <p:spPr>
            <a:xfrm>
              <a:off x="2745080" y="0"/>
              <a:ext cx="332740" cy="22415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lnSpc>
                  <a:spcPct val="106000"/>
                </a:lnSpc>
                <a:spcAft>
                  <a:spcPts val="800"/>
                </a:spcAft>
              </a:pPr>
              <a:r>
                <a:rPr lang="en-US" sz="1000" b="1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B.</a:t>
              </a:r>
              <a:endParaRPr lang="en-IN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2190A69A-CABC-77C0-4D1B-78C36EB56526}"/>
              </a:ext>
            </a:extLst>
          </p:cNvPr>
          <p:cNvSpPr txBox="1"/>
          <p:nvPr/>
        </p:nvSpPr>
        <p:spPr>
          <a:xfrm>
            <a:off x="5711986" y="50521"/>
            <a:ext cx="11797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IN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aikwad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 et al.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BBCC70F-0869-5833-9745-DD31DD3F1486}"/>
              </a:ext>
            </a:extLst>
          </p:cNvPr>
          <p:cNvSpPr txBox="1"/>
          <p:nvPr/>
        </p:nvSpPr>
        <p:spPr>
          <a:xfrm>
            <a:off x="669495" y="5635413"/>
            <a:ext cx="5862256" cy="14477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 Fig. 4 Sequential overexpression of 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uD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Msi2 causes decrease in the 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x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Bcl2 ratio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uD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Msi2 were sequentially overexpressed in N2a cells and the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x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Bcl2 ration was examined by western blotting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)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estern blot showing decrease in the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x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Bcl2 ration upon sequential overexpression of Hud and Msi2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raphical representation of the same</a:t>
            </a:r>
            <a:endParaRPr lang="en-IN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218165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0</TotalTime>
  <Words>75</Words>
  <Application>Microsoft Office PowerPoint</Application>
  <PresentationFormat>A4 Paper (210x297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ina gaikwad</dc:creator>
  <cp:lastModifiedBy>comp support</cp:lastModifiedBy>
  <cp:revision>22</cp:revision>
  <dcterms:created xsi:type="dcterms:W3CDTF">2022-09-05T06:06:19Z</dcterms:created>
  <dcterms:modified xsi:type="dcterms:W3CDTF">2024-12-01T12:26:35Z</dcterms:modified>
</cp:coreProperties>
</file>